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2" d="100"/>
          <a:sy n="62" d="100"/>
        </p:scale>
        <p:origin x="14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311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246"/>
            </a:lvl1pPr>
            <a:lvl2pPr marL="237390" indent="0" algn="ctr">
              <a:buNone/>
              <a:defRPr sz="1038"/>
            </a:lvl2pPr>
            <a:lvl3pPr marL="474779" indent="0" algn="ctr">
              <a:buNone/>
              <a:defRPr sz="935"/>
            </a:lvl3pPr>
            <a:lvl4pPr marL="712169" indent="0" algn="ctr">
              <a:buNone/>
              <a:defRPr sz="831"/>
            </a:lvl4pPr>
            <a:lvl5pPr marL="949559" indent="0" algn="ctr">
              <a:buNone/>
              <a:defRPr sz="831"/>
            </a:lvl5pPr>
            <a:lvl6pPr marL="1186948" indent="0" algn="ctr">
              <a:buNone/>
              <a:defRPr sz="831"/>
            </a:lvl6pPr>
            <a:lvl7pPr marL="1424338" indent="0" algn="ctr">
              <a:buNone/>
              <a:defRPr sz="831"/>
            </a:lvl7pPr>
            <a:lvl8pPr marL="1661728" indent="0" algn="ctr">
              <a:buNone/>
              <a:defRPr sz="831"/>
            </a:lvl8pPr>
            <a:lvl9pPr marL="1899117" indent="0" algn="ctr">
              <a:buNone/>
              <a:defRPr sz="831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678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4758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7865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734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311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246">
                <a:solidFill>
                  <a:schemeClr val="tx1"/>
                </a:solidFill>
              </a:defRPr>
            </a:lvl1pPr>
            <a:lvl2pPr marL="237390" indent="0">
              <a:buNone/>
              <a:defRPr sz="1038">
                <a:solidFill>
                  <a:schemeClr val="tx1">
                    <a:tint val="75000"/>
                  </a:schemeClr>
                </a:solidFill>
              </a:defRPr>
            </a:lvl2pPr>
            <a:lvl3pPr marL="474779" indent="0">
              <a:buNone/>
              <a:defRPr sz="935">
                <a:solidFill>
                  <a:schemeClr val="tx1">
                    <a:tint val="75000"/>
                  </a:schemeClr>
                </a:solidFill>
              </a:defRPr>
            </a:lvl3pPr>
            <a:lvl4pPr marL="712169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4pPr>
            <a:lvl5pPr marL="949559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5pPr>
            <a:lvl6pPr marL="118694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6pPr>
            <a:lvl7pPr marL="142433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7pPr>
            <a:lvl8pPr marL="166172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8pPr>
            <a:lvl9pPr marL="1899117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204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5835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1246" b="1"/>
            </a:lvl1pPr>
            <a:lvl2pPr marL="237390" indent="0">
              <a:buNone/>
              <a:defRPr sz="1038" b="1"/>
            </a:lvl2pPr>
            <a:lvl3pPr marL="474779" indent="0">
              <a:buNone/>
              <a:defRPr sz="935" b="1"/>
            </a:lvl3pPr>
            <a:lvl4pPr marL="712169" indent="0">
              <a:buNone/>
              <a:defRPr sz="831" b="1"/>
            </a:lvl4pPr>
            <a:lvl5pPr marL="949559" indent="0">
              <a:buNone/>
              <a:defRPr sz="831" b="1"/>
            </a:lvl5pPr>
            <a:lvl6pPr marL="1186948" indent="0">
              <a:buNone/>
              <a:defRPr sz="831" b="1"/>
            </a:lvl6pPr>
            <a:lvl7pPr marL="1424338" indent="0">
              <a:buNone/>
              <a:defRPr sz="831" b="1"/>
            </a:lvl7pPr>
            <a:lvl8pPr marL="1661728" indent="0">
              <a:buNone/>
              <a:defRPr sz="831" b="1"/>
            </a:lvl8pPr>
            <a:lvl9pPr marL="1899117" indent="0">
              <a:buNone/>
              <a:defRPr sz="831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1246" b="1"/>
            </a:lvl1pPr>
            <a:lvl2pPr marL="237390" indent="0">
              <a:buNone/>
              <a:defRPr sz="1038" b="1"/>
            </a:lvl2pPr>
            <a:lvl3pPr marL="474779" indent="0">
              <a:buNone/>
              <a:defRPr sz="935" b="1"/>
            </a:lvl3pPr>
            <a:lvl4pPr marL="712169" indent="0">
              <a:buNone/>
              <a:defRPr sz="831" b="1"/>
            </a:lvl4pPr>
            <a:lvl5pPr marL="949559" indent="0">
              <a:buNone/>
              <a:defRPr sz="831" b="1"/>
            </a:lvl5pPr>
            <a:lvl6pPr marL="1186948" indent="0">
              <a:buNone/>
              <a:defRPr sz="831" b="1"/>
            </a:lvl6pPr>
            <a:lvl7pPr marL="1424338" indent="0">
              <a:buNone/>
              <a:defRPr sz="831" b="1"/>
            </a:lvl7pPr>
            <a:lvl8pPr marL="1661728" indent="0">
              <a:buNone/>
              <a:defRPr sz="831" b="1"/>
            </a:lvl8pPr>
            <a:lvl9pPr marL="1899117" indent="0">
              <a:buNone/>
              <a:defRPr sz="831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533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4758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169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66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1662"/>
            </a:lvl1pPr>
            <a:lvl2pPr>
              <a:defRPr sz="1454"/>
            </a:lvl2pPr>
            <a:lvl3pPr>
              <a:defRPr sz="1246"/>
            </a:lvl3pPr>
            <a:lvl4pPr>
              <a:defRPr sz="1038"/>
            </a:lvl4pPr>
            <a:lvl5pPr>
              <a:defRPr sz="1038"/>
            </a:lvl5pPr>
            <a:lvl6pPr>
              <a:defRPr sz="1038"/>
            </a:lvl6pPr>
            <a:lvl7pPr>
              <a:defRPr sz="1038"/>
            </a:lvl7pPr>
            <a:lvl8pPr>
              <a:defRPr sz="1038"/>
            </a:lvl8pPr>
            <a:lvl9pPr>
              <a:defRPr sz="1038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831"/>
            </a:lvl1pPr>
            <a:lvl2pPr marL="237390" indent="0">
              <a:buNone/>
              <a:defRPr sz="727"/>
            </a:lvl2pPr>
            <a:lvl3pPr marL="474779" indent="0">
              <a:buNone/>
              <a:defRPr sz="623"/>
            </a:lvl3pPr>
            <a:lvl4pPr marL="712169" indent="0">
              <a:buNone/>
              <a:defRPr sz="519"/>
            </a:lvl4pPr>
            <a:lvl5pPr marL="949559" indent="0">
              <a:buNone/>
              <a:defRPr sz="519"/>
            </a:lvl5pPr>
            <a:lvl6pPr marL="1186948" indent="0">
              <a:buNone/>
              <a:defRPr sz="519"/>
            </a:lvl6pPr>
            <a:lvl7pPr marL="1424338" indent="0">
              <a:buNone/>
              <a:defRPr sz="519"/>
            </a:lvl7pPr>
            <a:lvl8pPr marL="1661728" indent="0">
              <a:buNone/>
              <a:defRPr sz="519"/>
            </a:lvl8pPr>
            <a:lvl9pPr marL="1899117" indent="0">
              <a:buNone/>
              <a:defRPr sz="519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0044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66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 anchor="t"/>
          <a:lstStyle>
            <a:lvl1pPr marL="0" indent="0">
              <a:buNone/>
              <a:defRPr sz="1662"/>
            </a:lvl1pPr>
            <a:lvl2pPr marL="237390" indent="0">
              <a:buNone/>
              <a:defRPr sz="1454"/>
            </a:lvl2pPr>
            <a:lvl3pPr marL="474779" indent="0">
              <a:buNone/>
              <a:defRPr sz="1246"/>
            </a:lvl3pPr>
            <a:lvl4pPr marL="712169" indent="0">
              <a:buNone/>
              <a:defRPr sz="1038"/>
            </a:lvl4pPr>
            <a:lvl5pPr marL="949559" indent="0">
              <a:buNone/>
              <a:defRPr sz="1038"/>
            </a:lvl5pPr>
            <a:lvl6pPr marL="1186948" indent="0">
              <a:buNone/>
              <a:defRPr sz="1038"/>
            </a:lvl6pPr>
            <a:lvl7pPr marL="1424338" indent="0">
              <a:buNone/>
              <a:defRPr sz="1038"/>
            </a:lvl7pPr>
            <a:lvl8pPr marL="1661728" indent="0">
              <a:buNone/>
              <a:defRPr sz="1038"/>
            </a:lvl8pPr>
            <a:lvl9pPr marL="1899117" indent="0">
              <a:buNone/>
              <a:defRPr sz="1038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831"/>
            </a:lvl1pPr>
            <a:lvl2pPr marL="237390" indent="0">
              <a:buNone/>
              <a:defRPr sz="727"/>
            </a:lvl2pPr>
            <a:lvl3pPr marL="474779" indent="0">
              <a:buNone/>
              <a:defRPr sz="623"/>
            </a:lvl3pPr>
            <a:lvl4pPr marL="712169" indent="0">
              <a:buNone/>
              <a:defRPr sz="519"/>
            </a:lvl4pPr>
            <a:lvl5pPr marL="949559" indent="0">
              <a:buNone/>
              <a:defRPr sz="519"/>
            </a:lvl5pPr>
            <a:lvl6pPr marL="1186948" indent="0">
              <a:buNone/>
              <a:defRPr sz="519"/>
            </a:lvl6pPr>
            <a:lvl7pPr marL="1424338" indent="0">
              <a:buNone/>
              <a:defRPr sz="519"/>
            </a:lvl7pPr>
            <a:lvl8pPr marL="1661728" indent="0">
              <a:buNone/>
              <a:defRPr sz="519"/>
            </a:lvl8pPr>
            <a:lvl9pPr marL="1899117" indent="0">
              <a:buNone/>
              <a:defRPr sz="519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824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5E2A57-4D04-4726-A3FC-076039359C33}" type="datetimeFigureOut">
              <a:rPr lang="fr-FR" smtClean="0"/>
              <a:t>17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1D6EA-6949-4BA8-9383-BB59B7B637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5155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74779" rtl="0" eaLnBrk="1" latinLnBrk="0" hangingPunct="1">
        <a:lnSpc>
          <a:spcPct val="90000"/>
        </a:lnSpc>
        <a:spcBef>
          <a:spcPct val="0"/>
        </a:spcBef>
        <a:buNone/>
        <a:defRPr sz="22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8695" indent="-118695" algn="l" defTabSz="474779" rtl="0" eaLnBrk="1" latinLnBrk="0" hangingPunct="1">
        <a:lnSpc>
          <a:spcPct val="90000"/>
        </a:lnSpc>
        <a:spcBef>
          <a:spcPts val="519"/>
        </a:spcBef>
        <a:buFont typeface="Arial" panose="020B0604020202020204" pitchFamily="34" charset="0"/>
        <a:buChar char="•"/>
        <a:defRPr sz="1454" kern="1200">
          <a:solidFill>
            <a:schemeClr val="tx1"/>
          </a:solidFill>
          <a:latin typeface="+mn-lt"/>
          <a:ea typeface="+mn-ea"/>
          <a:cs typeface="+mn-cs"/>
        </a:defRPr>
      </a:lvl1pPr>
      <a:lvl2pPr marL="356085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593474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038" kern="1200">
          <a:solidFill>
            <a:schemeClr val="tx1"/>
          </a:solidFill>
          <a:latin typeface="+mn-lt"/>
          <a:ea typeface="+mn-ea"/>
          <a:cs typeface="+mn-cs"/>
        </a:defRPr>
      </a:lvl3pPr>
      <a:lvl4pPr marL="830864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1068254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305643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33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780423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2017812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1pPr>
      <a:lvl2pPr marL="237390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2pPr>
      <a:lvl3pPr marL="474779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712169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949559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186948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424338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661728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1899117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1313311" y="1320035"/>
            <a:ext cx="9130317" cy="3704185"/>
            <a:chOff x="1251527" y="553916"/>
            <a:chExt cx="9130317" cy="3704185"/>
          </a:xfrm>
        </p:grpSpPr>
        <p:sp>
          <p:nvSpPr>
            <p:cNvPr id="8" name="Rectangle 7"/>
            <p:cNvSpPr/>
            <p:nvPr/>
          </p:nvSpPr>
          <p:spPr>
            <a:xfrm>
              <a:off x="1410918" y="553916"/>
              <a:ext cx="280846" cy="2840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316520"/>
              <a:r>
                <a:rPr lang="fr-FR" sz="1246" b="1" dirty="0">
                  <a:solidFill>
                    <a:prstClr val="black"/>
                  </a:solidFill>
                  <a:latin typeface="Calibri" panose="020F0502020204030204"/>
                </a:rPr>
                <a:t>A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5943064" y="553916"/>
              <a:ext cx="274434" cy="28405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316520"/>
              <a:r>
                <a:rPr lang="fr-FR" sz="1246" b="1" dirty="0">
                  <a:solidFill>
                    <a:prstClr val="black"/>
                  </a:solidFill>
                  <a:latin typeface="Calibri" panose="020F0502020204030204"/>
                </a:rPr>
                <a:t>B</a:t>
              </a:r>
            </a:p>
          </p:txBody>
        </p:sp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4827F2D1-5689-4C0C-AEF1-74442E0E27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44869" y="855370"/>
              <a:ext cx="4536975" cy="3402731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BE2AE2AE-5556-4DF9-8A9F-A669F29555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51527" y="855370"/>
              <a:ext cx="4536975" cy="3402731"/>
            </a:xfrm>
            <a:prstGeom prst="rect">
              <a:avLst/>
            </a:prstGeom>
          </p:spPr>
        </p:pic>
        <p:sp>
          <p:nvSpPr>
            <p:cNvPr id="6" name="ZoneTexte 7"/>
            <p:cNvSpPr txBox="1"/>
            <p:nvPr/>
          </p:nvSpPr>
          <p:spPr>
            <a:xfrm rot="16200000">
              <a:off x="5329290" y="2300018"/>
              <a:ext cx="147508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ZoneTexte 7"/>
            <p:cNvSpPr txBox="1"/>
            <p:nvPr/>
          </p:nvSpPr>
          <p:spPr>
            <a:xfrm rot="16200000">
              <a:off x="725947" y="2300018"/>
              <a:ext cx="147508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isease</a:t>
              </a:r>
              <a:r>
                <a:rPr lang="fr-F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free survival </a:t>
              </a:r>
              <a:r>
                <a:rPr lang="fr-F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robability</a:t>
              </a:r>
              <a:r>
                <a:rPr lang="fr-F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endParaRPr lang="fr-FR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Ellipse 2"/>
            <p:cNvSpPr/>
            <p:nvPr/>
          </p:nvSpPr>
          <p:spPr>
            <a:xfrm>
              <a:off x="6066832" y="1612900"/>
              <a:ext cx="92333" cy="85725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" name="Ellipse 3"/>
            <p:cNvSpPr/>
            <p:nvPr/>
          </p:nvSpPr>
          <p:spPr>
            <a:xfrm>
              <a:off x="1463489" y="1637407"/>
              <a:ext cx="148701" cy="67568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1" name="ZoneTexte 10"/>
          <p:cNvSpPr txBox="1"/>
          <p:nvPr/>
        </p:nvSpPr>
        <p:spPr>
          <a:xfrm>
            <a:off x="484094" y="466164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2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2286070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1</Words>
  <Application>Microsoft Office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Thème Office</vt:lpstr>
      <vt:lpstr>Présentation PowerPoint</vt:lpstr>
    </vt:vector>
  </TitlesOfParts>
  <Company>Institut Cur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ttu Paul</dc:creator>
  <cp:lastModifiedBy>Cottu Paul</cp:lastModifiedBy>
  <cp:revision>4</cp:revision>
  <dcterms:created xsi:type="dcterms:W3CDTF">2024-09-15T12:44:53Z</dcterms:created>
  <dcterms:modified xsi:type="dcterms:W3CDTF">2025-01-17T10:20:26Z</dcterms:modified>
</cp:coreProperties>
</file>